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3" r:id="rId2"/>
    <p:sldId id="265" r:id="rId3"/>
    <p:sldId id="264" r:id="rId4"/>
    <p:sldId id="26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6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D25DA3-BE9F-4333-A7AE-83CC17F7DA97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1F7EA8-3366-4178-8338-DDF20BC77F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79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I-1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olyethylene glycol molecular weight standards on TSK gel Alpha-3000 SEC 9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D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lecular weight cut-off. Standards and samples run in water at 1.0 mL mi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SEC polyethylene glycol standards (Agilen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asiVial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EG/PEO (P.N. 2080-0201)) were used to estimate the molecular weight ranges of chemical components in peel extracts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1F7EA8-3366-4178-8338-DDF20BC77F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1097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I-2.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20 column chromatogram of </a:t>
            </a:r>
            <a:r>
              <a:rPr lang="en-US" sz="1800" dirty="0">
                <a:effectLst/>
                <a:latin typeface="Segoe UI" panose="020B0502040204020203" pitchFamily="34" charset="0"/>
              </a:rPr>
              <a:t>methanol soluble clarified orange peel molass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1F7EA8-3366-4178-8338-DDF20BC77FA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8864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I-3. 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UV spectrum of the early-eluting LH20 “baseline” fraction of orange peel extrac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1F7EA8-3366-4178-8338-DDF20BC77FA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8462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I-4.  </a:t>
            </a:r>
            <a:r>
              <a:rPr lang="en-US" sz="1800" b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TIR of water-soluble portion of early-eluting LH20 column baseline fraction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1F7EA8-3366-4178-8338-DDF20BC77FA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641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9FF46-92C1-6CD3-FE58-297E0E77DB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8DEC64-438C-C317-2D98-2E3D44138A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0F7D5-873D-8906-AC4B-F3E015DF3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C3C6C-15DD-D825-1165-FE32BEA35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7681FE-3162-1113-AC98-0480616FC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744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4F0A9-088D-BA33-05F9-24F561879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CF78A2-DFD0-6B9E-EEAB-E6BA5F7C80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F29804-6216-F759-3207-42A34C9B1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6B9DA-C1AA-9CD2-D02C-A3B6445CA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0BE801-60C3-1FE8-2BEC-B44F4ED48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797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2BFA38-2BAB-2493-B7D1-D87E31F8DE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0D4093-E72B-D12E-23E9-09D3CB250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72F95E-1B82-1881-41C9-6EFF88977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EC32EF-CA6E-79E2-4DE8-B07B09C48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832B3-CF49-B448-37BE-8484D8BC3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157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2C965-B499-0F36-8732-2BDE5F69A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9A4FF8-A9A2-A981-CE25-C7B6131FF0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DA54D-E29B-9FD2-1AE6-79A05A638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65389-C6E8-B145-C3DE-C81021C3A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26DCA-5AE9-993B-C5A4-652DBF5D2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97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460B6-783C-94C0-FDE9-DD55D5DE5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9D7535-3CC1-A33E-7ED0-8A761FFF0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2AFC2C-763C-37A9-6E63-B62CD0AEA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892C1-B4DD-AB6D-3BB4-54802D29A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ACF568-54AA-3A36-450C-05EC4D342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236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540C32-0451-86E8-EBAD-178804F20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73BAA-F091-1186-297A-7077B54C27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92B610-7DD6-1C94-E924-14C6CB2A00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C6D2C2-F342-9BB5-2F65-792A4898C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2C4490-66AA-84AF-3861-20C67B1FF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605C97-CB33-E197-28A8-DD979CA20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89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68246-EEC0-B6C6-F5C4-4670CF678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F65E2C-4103-5CD3-F0C9-2615DECC5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511094-00EC-AEDC-9AA6-EA94E3BBC6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F880B7-C94E-81A0-1EA5-54B3BE4296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8EB1AA-0C77-7C59-D7C7-FA3662A566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F0AA9A-5EC5-F4B6-314F-CACFD94D4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A4D469-D763-CFEA-6A34-4F71C9B0F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02F23B-0229-8899-5DC6-C5FED8AF2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693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E3F368-3FEC-0643-BF21-E81F8AE5D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37B46E-BA3B-0D8E-5BA0-3C517A7CD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0AE6DA-1E69-5D06-8328-0DD340A1A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DED74E-1957-716A-3DD3-326A24A67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553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045503-E0EE-6F9A-2760-6787188BF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0E7035-82B3-CC6A-EECC-61D92C00A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1C74EA-45A3-E56E-830E-0F0926F6C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152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88CEA-397D-ED01-397D-0778523DF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894E2F-0159-9C07-F33A-1532929479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B35E4D-4047-ECD9-C563-47165896E9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CDA335-DB15-47AD-7DC6-3C8F1E448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52EDBB-E10F-7A6F-6AC6-2ECFAF9F0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D3E63D-24DF-21C3-AE17-491995121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3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1EBAE-3750-8EA2-DAE0-9759176E54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1A3701-7B1B-6DC6-CDB9-78E066633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36E398-3A75-0930-DFCF-ACFE1287EC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F424BA-D6F9-6A3D-090B-CD95346EB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3A1BBA-EF9F-6E93-FD39-BE492DFE6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122514-4F00-A8C4-E751-3BC482271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08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A5C052-ED30-0992-A28E-3CA47EC4C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F8A675-D7C7-BF65-18FE-50897E8CEB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45E10-FB32-0BD9-41D8-94027A3F8E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B8A0A-6474-441B-B35E-613143CF9BA3}" type="datetimeFigureOut">
              <a:rPr lang="en-US" smtClean="0"/>
              <a:t>3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46DFC-7770-2ED2-9AEB-877FAB7C8D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9B98B0-0FC1-160E-989D-C7C1C17A79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69F30D-F753-49B3-9356-511D790BC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06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5582B36-A5F7-C94A-FCD8-88A5E31CFAA7}"/>
              </a:ext>
            </a:extLst>
          </p:cNvPr>
          <p:cNvGrpSpPr/>
          <p:nvPr/>
        </p:nvGrpSpPr>
        <p:grpSpPr>
          <a:xfrm>
            <a:off x="2552326" y="492369"/>
            <a:ext cx="6549959" cy="3662065"/>
            <a:chOff x="2524191" y="1828800"/>
            <a:chExt cx="6549959" cy="366206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9D6169D-C76F-6C22-235D-1B8EF1279B6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17850" y="1828800"/>
              <a:ext cx="5956300" cy="3200400"/>
            </a:xfrm>
            <a:prstGeom prst="rect">
              <a:avLst/>
            </a:prstGeom>
            <a:noFill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0E0F90-A623-50C6-3B70-EEECC2855205}"/>
                </a:ext>
              </a:extLst>
            </p:cNvPr>
            <p:cNvSpPr txBox="1"/>
            <p:nvPr/>
          </p:nvSpPr>
          <p:spPr>
            <a:xfrm>
              <a:off x="4544666" y="5029200"/>
              <a:ext cx="293234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Retention Time (min)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0C592CC-4D93-340D-81B6-9A4AF1F130E9}"/>
                </a:ext>
              </a:extLst>
            </p:cNvPr>
            <p:cNvSpPr txBox="1"/>
            <p:nvPr/>
          </p:nvSpPr>
          <p:spPr>
            <a:xfrm rot="16200000">
              <a:off x="1503559" y="3121865"/>
              <a:ext cx="2502929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Molecular Weight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359E203-1564-76EB-22D0-2DD3CA774674}"/>
              </a:ext>
            </a:extLst>
          </p:cNvPr>
          <p:cNvSpPr txBox="1"/>
          <p:nvPr/>
        </p:nvSpPr>
        <p:spPr>
          <a:xfrm>
            <a:off x="1261403" y="4876198"/>
            <a:ext cx="1021314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I-1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olyethylene glycol molecular weight standards on TSK gel Alpha-3000 SEC 9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D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lecular weight cut-off. Standards and samples run in water at 1.0 mL mi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SEC polyethylene glycol standards (Agilen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asiVial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EG/PEO (P.N. 2080-0201)) were used to estimate the molecular weight ranges of chemical components in peel extracts. </a:t>
            </a:r>
            <a:endParaRPr lang="en-US" b="1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60207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870D815-5115-6131-5866-9D41DB34B3B0}"/>
              </a:ext>
            </a:extLst>
          </p:cNvPr>
          <p:cNvGrpSpPr/>
          <p:nvPr/>
        </p:nvGrpSpPr>
        <p:grpSpPr>
          <a:xfrm>
            <a:off x="1240740" y="1154112"/>
            <a:ext cx="9960660" cy="4549776"/>
            <a:chOff x="935940" y="1169439"/>
            <a:chExt cx="10066356" cy="472653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515EFE4-EE74-94ED-BC09-4CA3BE61A1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58638">
              <a:off x="2072632" y="1423823"/>
              <a:ext cx="8046736" cy="4093472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DF91AC47-D9DB-AEE0-B1E1-0BB9830232D5}"/>
                </a:ext>
              </a:extLst>
            </p:cNvPr>
            <p:cNvSpPr/>
            <p:nvPr/>
          </p:nvSpPr>
          <p:spPr>
            <a:xfrm>
              <a:off x="1543049" y="5375788"/>
              <a:ext cx="9459247" cy="5201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					Elution Volume (mL)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D149387F-D662-C00A-5EEE-9908250DCFEB}"/>
                </a:ext>
              </a:extLst>
            </p:cNvPr>
            <p:cNvCxnSpPr/>
            <p:nvPr/>
          </p:nvCxnSpPr>
          <p:spPr>
            <a:xfrm>
              <a:off x="1982500" y="5427408"/>
              <a:ext cx="772931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A19C3C58-BF5C-5E94-7229-FFE7737AEAF2}"/>
                </a:ext>
              </a:extLst>
            </p:cNvPr>
            <p:cNvCxnSpPr/>
            <p:nvPr/>
          </p:nvCxnSpPr>
          <p:spPr>
            <a:xfrm flipV="1">
              <a:off x="1982500" y="1240405"/>
              <a:ext cx="0" cy="418700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0A8E2BD-58F3-EAC5-1ED5-22597DE494B8}"/>
                </a:ext>
              </a:extLst>
            </p:cNvPr>
            <p:cNvSpPr txBox="1"/>
            <p:nvPr/>
          </p:nvSpPr>
          <p:spPr>
            <a:xfrm>
              <a:off x="1342503" y="4626690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0346696-9BBC-945D-422F-0CE868650DE3}"/>
                </a:ext>
              </a:extLst>
            </p:cNvPr>
            <p:cNvSpPr txBox="1"/>
            <p:nvPr/>
          </p:nvSpPr>
          <p:spPr>
            <a:xfrm>
              <a:off x="1342503" y="4050119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0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05A5B7A-8154-2AAB-74BF-EFDC7DDEB7CA}"/>
                </a:ext>
              </a:extLst>
            </p:cNvPr>
            <p:cNvSpPr txBox="1"/>
            <p:nvPr/>
          </p:nvSpPr>
          <p:spPr>
            <a:xfrm>
              <a:off x="1366179" y="3460335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88AE085-E715-72CB-D327-9441741256CD}"/>
                </a:ext>
              </a:extLst>
            </p:cNvPr>
            <p:cNvSpPr txBox="1"/>
            <p:nvPr/>
          </p:nvSpPr>
          <p:spPr>
            <a:xfrm>
              <a:off x="1368431" y="2919789"/>
              <a:ext cx="5549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8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06353A7-FBFC-D416-BBEB-3705527CA8B0}"/>
                </a:ext>
              </a:extLst>
            </p:cNvPr>
            <p:cNvSpPr txBox="1"/>
            <p:nvPr/>
          </p:nvSpPr>
          <p:spPr>
            <a:xfrm>
              <a:off x="1283828" y="2338385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00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462AD20-16FD-5929-3E7E-CA27A082779D}"/>
                </a:ext>
              </a:extLst>
            </p:cNvPr>
            <p:cNvSpPr txBox="1"/>
            <p:nvPr/>
          </p:nvSpPr>
          <p:spPr>
            <a:xfrm>
              <a:off x="1280787" y="1761034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2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566B970-C36A-B1A8-6156-988142DA44A6}"/>
                </a:ext>
              </a:extLst>
            </p:cNvPr>
            <p:cNvSpPr txBox="1"/>
            <p:nvPr/>
          </p:nvSpPr>
          <p:spPr>
            <a:xfrm>
              <a:off x="1280843" y="1169439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4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C72C268-755E-6AF8-3BA7-918B243A28FE}"/>
                </a:ext>
              </a:extLst>
            </p:cNvPr>
            <p:cNvSpPr txBox="1"/>
            <p:nvPr/>
          </p:nvSpPr>
          <p:spPr>
            <a:xfrm rot="16200000">
              <a:off x="622848" y="2781977"/>
              <a:ext cx="9955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AU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C1184B2-80CB-4226-5795-685581322AB9}"/>
              </a:ext>
            </a:extLst>
          </p:cNvPr>
          <p:cNvSpPr txBox="1"/>
          <p:nvPr/>
        </p:nvSpPr>
        <p:spPr>
          <a:xfrm>
            <a:off x="1406769" y="5852160"/>
            <a:ext cx="95800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I-2.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20 column chromatogram of </a:t>
            </a:r>
            <a:r>
              <a:rPr lang="en-US" sz="1800" dirty="0">
                <a:effectLst/>
                <a:latin typeface="Segoe UI" panose="020B0502040204020203" pitchFamily="34" charset="0"/>
              </a:rPr>
              <a:t>methanol soluble clarified orange peel molasses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4115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F7FC907-7068-81F6-5942-B91DFA4357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4972" y="1337375"/>
            <a:ext cx="3585642" cy="4183249"/>
          </a:xfrm>
          <a:prstGeom prst="rect">
            <a:avLst/>
          </a:prstGeom>
          <a:noFill/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6CDAB67-323A-F4DA-4B1D-B0B0C9FA30DE}"/>
              </a:ext>
            </a:extLst>
          </p:cNvPr>
          <p:cNvSpPr txBox="1"/>
          <p:nvPr/>
        </p:nvSpPr>
        <p:spPr>
          <a:xfrm>
            <a:off x="1378634" y="5697415"/>
            <a:ext cx="91580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I-3. 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UV spectrum of the early-eluting LH20 “baseline” fraction of orange peel extrac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1961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F81083B-C40A-A467-99F9-145346B89AD2}"/>
              </a:ext>
            </a:extLst>
          </p:cNvPr>
          <p:cNvGrpSpPr/>
          <p:nvPr/>
        </p:nvGrpSpPr>
        <p:grpSpPr>
          <a:xfrm>
            <a:off x="1637732" y="614149"/>
            <a:ext cx="8105839" cy="5363570"/>
            <a:chOff x="1637732" y="614149"/>
            <a:chExt cx="8105839" cy="536357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968B1B6-9F60-A136-809A-B469FA5939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7732" y="614149"/>
              <a:ext cx="8105839" cy="536357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6ADCB80-A507-412F-CEE9-DAA0797B7DC8}"/>
                </a:ext>
              </a:extLst>
            </p:cNvPr>
            <p:cNvSpPr txBox="1"/>
            <p:nvPr/>
          </p:nvSpPr>
          <p:spPr>
            <a:xfrm>
              <a:off x="2794000" y="5085013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314.27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C16DDFF-4AE6-A58C-6311-DD7951AD697E}"/>
                </a:ext>
              </a:extLst>
            </p:cNvPr>
            <p:cNvSpPr txBox="1"/>
            <p:nvPr/>
          </p:nvSpPr>
          <p:spPr>
            <a:xfrm>
              <a:off x="2971800" y="2664094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956.52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AB1C1F1-343D-B05D-3CE5-87A9FAE613BA}"/>
                </a:ext>
              </a:extLst>
            </p:cNvPr>
            <p:cNvSpPr txBox="1"/>
            <p:nvPr/>
          </p:nvSpPr>
          <p:spPr>
            <a:xfrm>
              <a:off x="3441700" y="3548699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927.53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757DB5E-B847-8A93-065B-5F9030936B1A}"/>
                </a:ext>
              </a:extLst>
            </p:cNvPr>
            <p:cNvSpPr txBox="1"/>
            <p:nvPr/>
          </p:nvSpPr>
          <p:spPr>
            <a:xfrm>
              <a:off x="5422900" y="4628199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645.06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249DEDE-E8A5-31D1-B9A9-73EE5DDD813A}"/>
                </a:ext>
              </a:extLst>
            </p:cNvPr>
            <p:cNvSpPr txBox="1"/>
            <p:nvPr/>
          </p:nvSpPr>
          <p:spPr>
            <a:xfrm>
              <a:off x="5981700" y="4049398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37.5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1854F82-B0E4-0A89-6A83-1BABAF1FE1FF}"/>
                </a:ext>
              </a:extLst>
            </p:cNvPr>
            <p:cNvSpPr txBox="1"/>
            <p:nvPr/>
          </p:nvSpPr>
          <p:spPr>
            <a:xfrm>
              <a:off x="6273800" y="3090446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439.97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C51ED92-7F1F-FBEF-D6E9-55FA7BCB81D0}"/>
                </a:ext>
              </a:extLst>
            </p:cNvPr>
            <p:cNvSpPr txBox="1"/>
            <p:nvPr/>
          </p:nvSpPr>
          <p:spPr>
            <a:xfrm>
              <a:off x="6032500" y="1666144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400.2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23EE2E8-1E73-A0C9-3517-FACE4ABE5BC3}"/>
                </a:ext>
              </a:extLst>
            </p:cNvPr>
            <p:cNvSpPr txBox="1"/>
            <p:nvPr/>
          </p:nvSpPr>
          <p:spPr>
            <a:xfrm>
              <a:off x="6591300" y="2664094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248.48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0A8391D-093C-C698-681C-C06A1577080F}"/>
                </a:ext>
              </a:extLst>
            </p:cNvPr>
            <p:cNvSpPr txBox="1"/>
            <p:nvPr/>
          </p:nvSpPr>
          <p:spPr>
            <a:xfrm>
              <a:off x="7391400" y="3143841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67.8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BFC6039-E125-DE30-DEA5-76C4578744A7}"/>
                </a:ext>
              </a:extLst>
            </p:cNvPr>
            <p:cNvSpPr txBox="1"/>
            <p:nvPr/>
          </p:nvSpPr>
          <p:spPr>
            <a:xfrm>
              <a:off x="7708900" y="2734691"/>
              <a:ext cx="1117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46.15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294A9903-C0A2-AB0C-616E-B7C58EA5AA83}"/>
                </a:ext>
              </a:extLst>
            </p:cNvPr>
            <p:cNvCxnSpPr/>
            <p:nvPr/>
          </p:nvCxnSpPr>
          <p:spPr>
            <a:xfrm flipV="1">
              <a:off x="3200400" y="5324475"/>
              <a:ext cx="0" cy="3429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75D326C1-9E74-EFDF-EDF5-6F65C6B0AB5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441700" y="2913493"/>
              <a:ext cx="225425" cy="41132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2E103B08-8124-6342-839C-814E71325AC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30341" y="3395866"/>
              <a:ext cx="181259" cy="22363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5A0A2432-8BB5-BF79-8C75-61B9BE29864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932345" y="4896533"/>
              <a:ext cx="39830" cy="42794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E28374C9-DFA5-60F3-A494-27CCAAE5468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273800" y="3960010"/>
              <a:ext cx="88900" cy="164315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41AAD493-E7F0-CAA4-870F-6C46DCFA9E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11925" y="2001229"/>
              <a:ext cx="0" cy="7334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BFB1D7DC-FCE0-E252-CD08-B5304122E6D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31100" y="2766596"/>
              <a:ext cx="214187" cy="44784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DBEC62E8-5DD3-EC8A-6CAA-29A67833ECD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632701" y="2756084"/>
              <a:ext cx="406147" cy="352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D4DA841-3627-9726-A9DB-7BBE3A5F3F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16700" y="2832077"/>
              <a:ext cx="0" cy="27755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AC791427-566B-4F1D-187E-D055D42E9BB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48500" y="2535475"/>
              <a:ext cx="0" cy="199216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93AB6588-4548-4255-090E-7D26578248AF}"/>
              </a:ext>
            </a:extLst>
          </p:cNvPr>
          <p:cNvSpPr txBox="1"/>
          <p:nvPr/>
        </p:nvSpPr>
        <p:spPr>
          <a:xfrm>
            <a:off x="1786206" y="6146286"/>
            <a:ext cx="89751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I-4.  </a:t>
            </a:r>
            <a:r>
              <a:rPr lang="en-US" sz="1800" b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TIR of water-soluble portion of early-eluting LH20 column baseline fraction</a:t>
            </a:r>
            <a:endParaRPr lang="en-US" b="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0503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3</TotalTime>
  <Words>253</Words>
  <Application>Microsoft Office PowerPoint</Application>
  <PresentationFormat>Widescreen</PresentationFormat>
  <Paragraphs>33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Segoe U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ffries, Kristen - REE-ARS</dc:creator>
  <cp:lastModifiedBy>Jeffries, Kristen - REE-ARS</cp:lastModifiedBy>
  <cp:revision>22</cp:revision>
  <dcterms:created xsi:type="dcterms:W3CDTF">2024-08-29T12:57:27Z</dcterms:created>
  <dcterms:modified xsi:type="dcterms:W3CDTF">2025-03-13T19:29:34Z</dcterms:modified>
</cp:coreProperties>
</file>